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6400800" cy="2286000"/>
  <p:notesSz cx="6858000" cy="9144000"/>
  <p:defaultTextStyle>
    <a:defPPr>
      <a:defRPr lang="en-US"/>
    </a:defPPr>
    <a:lvl1pPr marL="0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1pPr>
    <a:lvl2pPr marL="241402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2pPr>
    <a:lvl3pPr marL="482803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3pPr>
    <a:lvl4pPr marL="724205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4pPr>
    <a:lvl5pPr marL="965606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5pPr>
    <a:lvl6pPr marL="1207008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6pPr>
    <a:lvl7pPr marL="1448410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7pPr>
    <a:lvl8pPr marL="1689811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8pPr>
    <a:lvl9pPr marL="1931213" algn="l" defTabSz="482803" rtl="0" eaLnBrk="1" latinLnBrk="0" hangingPunct="1">
      <a:defRPr sz="9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20" userDrawn="1">
          <p15:clr>
            <a:srgbClr val="A4A3A4"/>
          </p15:clr>
        </p15:guide>
        <p15:guide id="2" pos="20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586"/>
  </p:normalViewPr>
  <p:slideViewPr>
    <p:cSldViewPr snapToGrid="0" snapToObjects="1" showGuides="1">
      <p:cViewPr varScale="1">
        <p:scale>
          <a:sx n="200" d="100"/>
          <a:sy n="200" d="100"/>
        </p:scale>
        <p:origin x="176" y="776"/>
      </p:cViewPr>
      <p:guideLst>
        <p:guide orient="horz" pos="720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0100" y="374121"/>
            <a:ext cx="4800600" cy="795867"/>
          </a:xfrm>
        </p:spPr>
        <p:txBody>
          <a:bodyPr anchor="b"/>
          <a:lstStyle>
            <a:lvl1pPr algn="ctr">
              <a:defRPr sz="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1200679"/>
            <a:ext cx="4800600" cy="551921"/>
          </a:xfrm>
        </p:spPr>
        <p:txBody>
          <a:bodyPr/>
          <a:lstStyle>
            <a:lvl1pPr marL="0" indent="0" algn="ctr">
              <a:buNone/>
              <a:defRPr sz="800"/>
            </a:lvl1pPr>
            <a:lvl2pPr marL="152385" indent="0" algn="ctr">
              <a:buNone/>
              <a:defRPr sz="667"/>
            </a:lvl2pPr>
            <a:lvl3pPr marL="304770" indent="0" algn="ctr">
              <a:buNone/>
              <a:defRPr sz="600"/>
            </a:lvl3pPr>
            <a:lvl4pPr marL="457154" indent="0" algn="ctr">
              <a:buNone/>
              <a:defRPr sz="533"/>
            </a:lvl4pPr>
            <a:lvl5pPr marL="609539" indent="0" algn="ctr">
              <a:buNone/>
              <a:defRPr sz="533"/>
            </a:lvl5pPr>
            <a:lvl6pPr marL="761924" indent="0" algn="ctr">
              <a:buNone/>
              <a:defRPr sz="533"/>
            </a:lvl6pPr>
            <a:lvl7pPr marL="914309" indent="0" algn="ctr">
              <a:buNone/>
              <a:defRPr sz="533"/>
            </a:lvl7pPr>
            <a:lvl8pPr marL="1066693" indent="0" algn="ctr">
              <a:buNone/>
              <a:defRPr sz="533"/>
            </a:lvl8pPr>
            <a:lvl9pPr marL="1219078" indent="0" algn="ctr">
              <a:buNone/>
              <a:defRPr sz="5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9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20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2" y="121709"/>
            <a:ext cx="1380173" cy="19372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121709"/>
            <a:ext cx="4060508" cy="19372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123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088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1" y="569913"/>
            <a:ext cx="5520690" cy="950912"/>
          </a:xfrm>
        </p:spPr>
        <p:txBody>
          <a:bodyPr anchor="b"/>
          <a:lstStyle>
            <a:lvl1pPr>
              <a:defRPr sz="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1" y="1529821"/>
            <a:ext cx="5520690" cy="500062"/>
          </a:xfrm>
        </p:spPr>
        <p:txBody>
          <a:bodyPr/>
          <a:lstStyle>
            <a:lvl1pPr marL="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1pPr>
            <a:lvl2pPr marL="152385" indent="0">
              <a:buNone/>
              <a:defRPr sz="667">
                <a:solidFill>
                  <a:schemeClr val="tx1">
                    <a:tint val="75000"/>
                  </a:schemeClr>
                </a:solidFill>
              </a:defRPr>
            </a:lvl2pPr>
            <a:lvl3pPr marL="304770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457154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4pPr>
            <a:lvl5pPr marL="609539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5pPr>
            <a:lvl6pPr marL="761924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6pPr>
            <a:lvl7pPr marL="914309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7pPr>
            <a:lvl8pPr marL="1066693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8pPr>
            <a:lvl9pPr marL="1219078" indent="0">
              <a:buNone/>
              <a:defRPr sz="5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816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608542"/>
            <a:ext cx="2720340" cy="145044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608542"/>
            <a:ext cx="2720340" cy="145044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976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21709"/>
            <a:ext cx="5520690" cy="44185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560388"/>
            <a:ext cx="2707838" cy="274637"/>
          </a:xfrm>
        </p:spPr>
        <p:txBody>
          <a:bodyPr anchor="b"/>
          <a:lstStyle>
            <a:lvl1pPr marL="0" indent="0">
              <a:buNone/>
              <a:defRPr sz="800" b="1"/>
            </a:lvl1pPr>
            <a:lvl2pPr marL="152385" indent="0">
              <a:buNone/>
              <a:defRPr sz="667" b="1"/>
            </a:lvl2pPr>
            <a:lvl3pPr marL="304770" indent="0">
              <a:buNone/>
              <a:defRPr sz="600" b="1"/>
            </a:lvl3pPr>
            <a:lvl4pPr marL="457154" indent="0">
              <a:buNone/>
              <a:defRPr sz="533" b="1"/>
            </a:lvl4pPr>
            <a:lvl5pPr marL="609539" indent="0">
              <a:buNone/>
              <a:defRPr sz="533" b="1"/>
            </a:lvl5pPr>
            <a:lvl6pPr marL="761924" indent="0">
              <a:buNone/>
              <a:defRPr sz="533" b="1"/>
            </a:lvl6pPr>
            <a:lvl7pPr marL="914309" indent="0">
              <a:buNone/>
              <a:defRPr sz="533" b="1"/>
            </a:lvl7pPr>
            <a:lvl8pPr marL="1066693" indent="0">
              <a:buNone/>
              <a:defRPr sz="533" b="1"/>
            </a:lvl8pPr>
            <a:lvl9pPr marL="1219078" indent="0">
              <a:buNone/>
              <a:defRPr sz="5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835025"/>
            <a:ext cx="2707838" cy="122819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560388"/>
            <a:ext cx="2721174" cy="274637"/>
          </a:xfrm>
        </p:spPr>
        <p:txBody>
          <a:bodyPr anchor="b"/>
          <a:lstStyle>
            <a:lvl1pPr marL="0" indent="0">
              <a:buNone/>
              <a:defRPr sz="800" b="1"/>
            </a:lvl1pPr>
            <a:lvl2pPr marL="152385" indent="0">
              <a:buNone/>
              <a:defRPr sz="667" b="1"/>
            </a:lvl2pPr>
            <a:lvl3pPr marL="304770" indent="0">
              <a:buNone/>
              <a:defRPr sz="600" b="1"/>
            </a:lvl3pPr>
            <a:lvl4pPr marL="457154" indent="0">
              <a:buNone/>
              <a:defRPr sz="533" b="1"/>
            </a:lvl4pPr>
            <a:lvl5pPr marL="609539" indent="0">
              <a:buNone/>
              <a:defRPr sz="533" b="1"/>
            </a:lvl5pPr>
            <a:lvl6pPr marL="761924" indent="0">
              <a:buNone/>
              <a:defRPr sz="533" b="1"/>
            </a:lvl6pPr>
            <a:lvl7pPr marL="914309" indent="0">
              <a:buNone/>
              <a:defRPr sz="533" b="1"/>
            </a:lvl7pPr>
            <a:lvl8pPr marL="1066693" indent="0">
              <a:buNone/>
              <a:defRPr sz="533" b="1"/>
            </a:lvl8pPr>
            <a:lvl9pPr marL="1219078" indent="0">
              <a:buNone/>
              <a:defRPr sz="5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835025"/>
            <a:ext cx="2721174" cy="122819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064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686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712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52400"/>
            <a:ext cx="2064424" cy="533400"/>
          </a:xfrm>
        </p:spPr>
        <p:txBody>
          <a:bodyPr anchor="b"/>
          <a:lstStyle>
            <a:lvl1pPr>
              <a:defRPr sz="10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329142"/>
            <a:ext cx="3240405" cy="1624542"/>
          </a:xfrm>
        </p:spPr>
        <p:txBody>
          <a:bodyPr/>
          <a:lstStyle>
            <a:lvl1pPr>
              <a:defRPr sz="1067"/>
            </a:lvl1pPr>
            <a:lvl2pPr>
              <a:defRPr sz="933"/>
            </a:lvl2pPr>
            <a:lvl3pPr>
              <a:defRPr sz="800"/>
            </a:lvl3pPr>
            <a:lvl4pPr>
              <a:defRPr sz="667"/>
            </a:lvl4pPr>
            <a:lvl5pPr>
              <a:defRPr sz="667"/>
            </a:lvl5pPr>
            <a:lvl6pPr>
              <a:defRPr sz="667"/>
            </a:lvl6pPr>
            <a:lvl7pPr>
              <a:defRPr sz="667"/>
            </a:lvl7pPr>
            <a:lvl8pPr>
              <a:defRPr sz="667"/>
            </a:lvl8pPr>
            <a:lvl9pPr>
              <a:defRPr sz="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685800"/>
            <a:ext cx="2064424" cy="1270529"/>
          </a:xfrm>
        </p:spPr>
        <p:txBody>
          <a:bodyPr/>
          <a:lstStyle>
            <a:lvl1pPr marL="0" indent="0">
              <a:buNone/>
              <a:defRPr sz="533"/>
            </a:lvl1pPr>
            <a:lvl2pPr marL="152385" indent="0">
              <a:buNone/>
              <a:defRPr sz="467"/>
            </a:lvl2pPr>
            <a:lvl3pPr marL="304770" indent="0">
              <a:buNone/>
              <a:defRPr sz="400"/>
            </a:lvl3pPr>
            <a:lvl4pPr marL="457154" indent="0">
              <a:buNone/>
              <a:defRPr sz="333"/>
            </a:lvl4pPr>
            <a:lvl5pPr marL="609539" indent="0">
              <a:buNone/>
              <a:defRPr sz="333"/>
            </a:lvl5pPr>
            <a:lvl6pPr marL="761924" indent="0">
              <a:buNone/>
              <a:defRPr sz="333"/>
            </a:lvl6pPr>
            <a:lvl7pPr marL="914309" indent="0">
              <a:buNone/>
              <a:defRPr sz="333"/>
            </a:lvl7pPr>
            <a:lvl8pPr marL="1066693" indent="0">
              <a:buNone/>
              <a:defRPr sz="333"/>
            </a:lvl8pPr>
            <a:lvl9pPr marL="1219078" indent="0">
              <a:buNone/>
              <a:defRPr sz="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34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52400"/>
            <a:ext cx="2064424" cy="533400"/>
          </a:xfrm>
        </p:spPr>
        <p:txBody>
          <a:bodyPr anchor="b"/>
          <a:lstStyle>
            <a:lvl1pPr>
              <a:defRPr sz="10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329142"/>
            <a:ext cx="3240405" cy="1624542"/>
          </a:xfrm>
        </p:spPr>
        <p:txBody>
          <a:bodyPr anchor="t"/>
          <a:lstStyle>
            <a:lvl1pPr marL="0" indent="0">
              <a:buNone/>
              <a:defRPr sz="1067"/>
            </a:lvl1pPr>
            <a:lvl2pPr marL="152385" indent="0">
              <a:buNone/>
              <a:defRPr sz="933"/>
            </a:lvl2pPr>
            <a:lvl3pPr marL="304770" indent="0">
              <a:buNone/>
              <a:defRPr sz="800"/>
            </a:lvl3pPr>
            <a:lvl4pPr marL="457154" indent="0">
              <a:buNone/>
              <a:defRPr sz="667"/>
            </a:lvl4pPr>
            <a:lvl5pPr marL="609539" indent="0">
              <a:buNone/>
              <a:defRPr sz="667"/>
            </a:lvl5pPr>
            <a:lvl6pPr marL="761924" indent="0">
              <a:buNone/>
              <a:defRPr sz="667"/>
            </a:lvl6pPr>
            <a:lvl7pPr marL="914309" indent="0">
              <a:buNone/>
              <a:defRPr sz="667"/>
            </a:lvl7pPr>
            <a:lvl8pPr marL="1066693" indent="0">
              <a:buNone/>
              <a:defRPr sz="667"/>
            </a:lvl8pPr>
            <a:lvl9pPr marL="1219078" indent="0">
              <a:buNone/>
              <a:defRPr sz="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685800"/>
            <a:ext cx="2064424" cy="1270529"/>
          </a:xfrm>
        </p:spPr>
        <p:txBody>
          <a:bodyPr/>
          <a:lstStyle>
            <a:lvl1pPr marL="0" indent="0">
              <a:buNone/>
              <a:defRPr sz="533"/>
            </a:lvl1pPr>
            <a:lvl2pPr marL="152385" indent="0">
              <a:buNone/>
              <a:defRPr sz="467"/>
            </a:lvl2pPr>
            <a:lvl3pPr marL="304770" indent="0">
              <a:buNone/>
              <a:defRPr sz="400"/>
            </a:lvl3pPr>
            <a:lvl4pPr marL="457154" indent="0">
              <a:buNone/>
              <a:defRPr sz="333"/>
            </a:lvl4pPr>
            <a:lvl5pPr marL="609539" indent="0">
              <a:buNone/>
              <a:defRPr sz="333"/>
            </a:lvl5pPr>
            <a:lvl6pPr marL="761924" indent="0">
              <a:buNone/>
              <a:defRPr sz="333"/>
            </a:lvl6pPr>
            <a:lvl7pPr marL="914309" indent="0">
              <a:buNone/>
              <a:defRPr sz="333"/>
            </a:lvl7pPr>
            <a:lvl8pPr marL="1066693" indent="0">
              <a:buNone/>
              <a:defRPr sz="333"/>
            </a:lvl8pPr>
            <a:lvl9pPr marL="1219078" indent="0">
              <a:buNone/>
              <a:defRPr sz="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404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121709"/>
            <a:ext cx="5520690" cy="4418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608542"/>
            <a:ext cx="5520690" cy="14504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2118784"/>
            <a:ext cx="1440180" cy="121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69F19-E257-A54D-871E-71E11C33B25F}" type="datetimeFigureOut">
              <a:rPr lang="en-US" smtClean="0"/>
              <a:t>8/2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2118784"/>
            <a:ext cx="2160270" cy="121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2118784"/>
            <a:ext cx="1440180" cy="121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4D33C-7E66-A040-AD3E-5DD19A836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271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04770" rtl="0" eaLnBrk="1" latinLnBrk="0" hangingPunct="1">
        <a:lnSpc>
          <a:spcPct val="90000"/>
        </a:lnSpc>
        <a:spcBef>
          <a:spcPct val="0"/>
        </a:spcBef>
        <a:buNone/>
        <a:defRPr sz="14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192" indent="-76192" algn="l" defTabSz="30477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933" kern="1200">
          <a:solidFill>
            <a:schemeClr val="tx1"/>
          </a:solidFill>
          <a:latin typeface="+mn-lt"/>
          <a:ea typeface="+mn-ea"/>
          <a:cs typeface="+mn-cs"/>
        </a:defRPr>
      </a:lvl1pPr>
      <a:lvl2pPr marL="228577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2pPr>
      <a:lvl3pPr marL="380962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67" kern="1200">
          <a:solidFill>
            <a:schemeClr val="tx1"/>
          </a:solidFill>
          <a:latin typeface="+mn-lt"/>
          <a:ea typeface="+mn-ea"/>
          <a:cs typeface="+mn-cs"/>
        </a:defRPr>
      </a:lvl3pPr>
      <a:lvl4pPr marL="533347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4pPr>
      <a:lvl5pPr marL="685731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5pPr>
      <a:lvl6pPr marL="838116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6pPr>
      <a:lvl7pPr marL="990501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7pPr>
      <a:lvl8pPr marL="1142886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8pPr>
      <a:lvl9pPr marL="1295270" indent="-76192" algn="l" defTabSz="30477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1pPr>
      <a:lvl2pPr marL="152385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304770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3pPr>
      <a:lvl4pPr marL="457154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4pPr>
      <a:lvl5pPr marL="609539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5pPr>
      <a:lvl6pPr marL="761924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6pPr>
      <a:lvl7pPr marL="914309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7pPr>
      <a:lvl8pPr marL="1066693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8pPr>
      <a:lvl9pPr marL="1219078" algn="l" defTabSz="304770" rtl="0" eaLnBrk="1" latinLnBrk="0" hangingPunct="1">
        <a:defRPr sz="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36849F52-32F5-E24A-8EAD-27EAF0BEB8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0551292"/>
              </p:ext>
            </p:extLst>
          </p:nvPr>
        </p:nvGraphicFramePr>
        <p:xfrm>
          <a:off x="209548" y="337217"/>
          <a:ext cx="5803901" cy="169545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183967">
                  <a:extLst>
                    <a:ext uri="{9D8B030D-6E8A-4147-A177-3AD203B41FA5}">
                      <a16:colId xmlns:a16="http://schemas.microsoft.com/office/drawing/2014/main" val="3695555382"/>
                    </a:ext>
                  </a:extLst>
                </a:gridCol>
                <a:gridCol w="1002889">
                  <a:extLst>
                    <a:ext uri="{9D8B030D-6E8A-4147-A177-3AD203B41FA5}">
                      <a16:colId xmlns:a16="http://schemas.microsoft.com/office/drawing/2014/main" val="259462327"/>
                    </a:ext>
                  </a:extLst>
                </a:gridCol>
                <a:gridCol w="723409">
                  <a:extLst>
                    <a:ext uri="{9D8B030D-6E8A-4147-A177-3AD203B41FA5}">
                      <a16:colId xmlns:a16="http://schemas.microsoft.com/office/drawing/2014/main" val="1075893000"/>
                    </a:ext>
                  </a:extLst>
                </a:gridCol>
                <a:gridCol w="723409">
                  <a:extLst>
                    <a:ext uri="{9D8B030D-6E8A-4147-A177-3AD203B41FA5}">
                      <a16:colId xmlns:a16="http://schemas.microsoft.com/office/drawing/2014/main" val="581206882"/>
                    </a:ext>
                  </a:extLst>
                </a:gridCol>
                <a:gridCol w="723409">
                  <a:extLst>
                    <a:ext uri="{9D8B030D-6E8A-4147-A177-3AD203B41FA5}">
                      <a16:colId xmlns:a16="http://schemas.microsoft.com/office/drawing/2014/main" val="955383770"/>
                    </a:ext>
                  </a:extLst>
                </a:gridCol>
                <a:gridCol w="723409">
                  <a:extLst>
                    <a:ext uri="{9D8B030D-6E8A-4147-A177-3AD203B41FA5}">
                      <a16:colId xmlns:a16="http://schemas.microsoft.com/office/drawing/2014/main" val="3116022140"/>
                    </a:ext>
                  </a:extLst>
                </a:gridCol>
                <a:gridCol w="723409">
                  <a:extLst>
                    <a:ext uri="{9D8B030D-6E8A-4147-A177-3AD203B41FA5}">
                      <a16:colId xmlns:a16="http://schemas.microsoft.com/office/drawing/2014/main" val="33258249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L1 IC 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L1 TC (%)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s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3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B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b)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814827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Helvetica" pitchFamily="2" charset="0"/>
                        </a:rPr>
                        <a:t>8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157582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08482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Helvetica" pitchFamily="2" charset="0"/>
                        </a:rPr>
                        <a:t>0.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313667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 Percenti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Helvetica" pitchFamily="2" charset="0"/>
                        </a:rPr>
                        <a:t>3.51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92725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Helvetica" pitchFamily="2" charset="0"/>
                        </a:rPr>
                        <a:t>5.26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64481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% Percenti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Helvetica" pitchFamily="2" charset="0"/>
                        </a:rPr>
                        <a:t>7.90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01601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8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Helvetica" pitchFamily="2" charset="0"/>
                        </a:rPr>
                        <a:t>15.7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0370392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E03FA63C-8650-AF41-85F5-6E5035EA5221}"/>
              </a:ext>
            </a:extLst>
          </p:cNvPr>
          <p:cNvSpPr txBox="1"/>
          <p:nvPr/>
        </p:nvSpPr>
        <p:spPr>
          <a:xfrm>
            <a:off x="171448" y="90996"/>
            <a:ext cx="5880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 </a:t>
            </a:r>
          </a:p>
        </p:txBody>
      </p:sp>
    </p:spTree>
    <p:extLst>
      <p:ext uri="{BB962C8B-B14F-4D97-AF65-F5344CB8AC3E}">
        <p14:creationId xmlns:p14="http://schemas.microsoft.com/office/powerpoint/2010/main" val="927124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</TotalTime>
  <Words>68</Words>
  <Application>Microsoft Macintosh PowerPoint</Application>
  <PresentationFormat>Custom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jin Li</dc:creator>
  <cp:lastModifiedBy>lucianamolinero@gmail.com</cp:lastModifiedBy>
  <cp:revision>12</cp:revision>
  <dcterms:created xsi:type="dcterms:W3CDTF">2019-06-21T23:26:27Z</dcterms:created>
  <dcterms:modified xsi:type="dcterms:W3CDTF">2019-08-22T16:21:29Z</dcterms:modified>
</cp:coreProperties>
</file>